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53" d="100"/>
          <a:sy n="53" d="100"/>
        </p:scale>
        <p:origin x="18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8907" y="1166300"/>
            <a:ext cx="3430975" cy="1242976"/>
          </a:xfrm>
          <a:prstGeom prst="rect">
            <a:avLst/>
          </a:prstGeom>
        </p:spPr>
      </p:pic>
      <p:pic>
        <p:nvPicPr>
          <p:cNvPr id="6" name="圖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4122" y="1166713"/>
            <a:ext cx="3579401" cy="1356593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6120" y="3453484"/>
            <a:ext cx="3435404" cy="1360623"/>
          </a:xfrm>
          <a:prstGeom prst="rect">
            <a:avLst/>
          </a:prstGeom>
        </p:spPr>
      </p:pic>
      <p:graphicFrame>
        <p:nvGraphicFramePr>
          <p:cNvPr id="14" name="表格 13"/>
          <p:cNvGraphicFramePr>
            <a:graphicFrameLocks noGrp="1"/>
          </p:cNvGraphicFramePr>
          <p:nvPr/>
        </p:nvGraphicFramePr>
        <p:xfrm>
          <a:off x="49512" y="5434694"/>
          <a:ext cx="12092957" cy="1158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6997"/>
                <a:gridCol w="848161"/>
                <a:gridCol w="952500"/>
                <a:gridCol w="6819900"/>
                <a:gridCol w="1320800"/>
                <a:gridCol w="1244599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 smtClean="0"/>
                        <a:t>No.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 smtClean="0"/>
                        <a:t>Target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 smtClean="0"/>
                        <a:t>Dilution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 smtClean="0"/>
                        <a:t>Company and Catalog No.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 smtClean="0"/>
                        <a:t>Predicted MW (</a:t>
                      </a:r>
                      <a:r>
                        <a:rPr lang="en-US" altLang="zh-TW" sz="1600" dirty="0" err="1" smtClean="0"/>
                        <a:t>kDa</a:t>
                      </a:r>
                      <a:r>
                        <a:rPr lang="en-US" altLang="zh-TW" sz="1600" dirty="0" smtClean="0"/>
                        <a:t>)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b="1" i="0" kern="1200" dirty="0" smtClean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bserved MW (</a:t>
                      </a:r>
                      <a:r>
                        <a:rPr lang="en-US" altLang="zh-TW" sz="1600" b="1" i="0" kern="1200" dirty="0" err="1" smtClean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Da</a:t>
                      </a:r>
                      <a:r>
                        <a:rPr lang="en-US" altLang="zh-TW" sz="1600" b="1" i="0" kern="1200" dirty="0" smtClean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zh-TW" altLang="en-US" sz="1600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 smtClean="0"/>
                        <a:t>01</a:t>
                      </a:r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 smtClean="0"/>
                        <a:t>P-</a:t>
                      </a:r>
                      <a:r>
                        <a:rPr lang="en-US" altLang="zh-TW" dirty="0" err="1" smtClean="0"/>
                        <a:t>Erk</a:t>
                      </a:r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dirty="0" smtClean="0"/>
                        <a:t>1:2000</a:t>
                      </a:r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 smtClean="0"/>
                        <a:t>Cell Signaling, Phospho-p44/42 MAPK ( </a:t>
                      </a:r>
                      <a:r>
                        <a:rPr lang="en-US" altLang="zh-TW" sz="1600" dirty="0" err="1" smtClean="0"/>
                        <a:t>Erk</a:t>
                      </a:r>
                      <a:r>
                        <a:rPr lang="en-US" altLang="zh-TW" sz="1600" dirty="0" smtClean="0"/>
                        <a:t> 1/2 )(Thr202/Tyr204)(D13.14.4E) Rabbit </a:t>
                      </a:r>
                      <a:r>
                        <a:rPr lang="en-US" altLang="zh-TW" sz="1600" dirty="0" err="1" smtClean="0"/>
                        <a:t>mAb</a:t>
                      </a:r>
                      <a:r>
                        <a:rPr lang="en-US" altLang="zh-TW" sz="1600" dirty="0" smtClean="0"/>
                        <a:t>,  #4370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TW" sz="1600" dirty="0" smtClean="0"/>
                        <a:t>42,44</a:t>
                      </a:r>
                      <a:endParaRPr lang="zh-TW" alt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TW" sz="1600" dirty="0" smtClean="0"/>
                        <a:t>42,44</a:t>
                      </a:r>
                      <a:endParaRPr lang="zh-TW" altLang="en-US" sz="16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</Words>
  <Application>WPS Presentation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SimSun</vt:lpstr>
      <vt:lpstr>Wingdings</vt:lpstr>
      <vt:lpstr>Calibri Light</vt:lpstr>
      <vt:lpstr>Calibri</vt:lpstr>
      <vt:lpstr>Microsoft YaHei</vt:lpstr>
      <vt:lpstr>Arial Unicode MS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/>
  <cp:lastModifiedBy>dr.bamodu</cp:lastModifiedBy>
  <cp:revision>1</cp:revision>
  <dcterms:created xsi:type="dcterms:W3CDTF">2019-09-14T05:11:34Z</dcterms:created>
  <dcterms:modified xsi:type="dcterms:W3CDTF">2019-09-14T05:11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8888</vt:lpwstr>
  </property>
</Properties>
</file>